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934200" cy="9220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D7651E-C784-4360-AAF7-C728850F1B3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667C70-013E-4EF1-BF9C-DF57066CBD7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8E418A-89A4-41E2-97F1-A31C2999B40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DE2E8B-EF3A-48C5-878A-D4508BE5D00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B6F02E-0F3E-4B7A-88DD-722F9C7F0F7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F23B82-196A-465C-ADE8-F4AA7D7E34E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5E0F46-DD5C-440D-9BBC-5B5A75016C8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1D7840-303F-4F92-8799-3539CBD4024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DC76FE-0F41-4902-A925-8DB4656EC5D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442CDA-419D-437A-B160-8E4F14141F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9D545B-9828-4628-B81B-27B86DB4C4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C57D0B-CB25-468A-8098-903EBD73D3D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E422531-FDE4-4845-B7AD-45CA89ADE661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" descr=""/>
          <p:cNvPicPr/>
          <p:nvPr/>
        </p:nvPicPr>
        <p:blipFill>
          <a:blip r:embed="rId1"/>
          <a:stretch/>
        </p:blipFill>
        <p:spPr>
          <a:xfrm>
            <a:off x="380880" y="1173240"/>
            <a:ext cx="4684680" cy="3200400"/>
          </a:xfrm>
          <a:prstGeom prst="rect">
            <a:avLst/>
          </a:prstGeom>
          <a:ln w="0">
            <a:noFill/>
          </a:ln>
        </p:spPr>
      </p:pic>
      <p:sp>
        <p:nvSpPr>
          <p:cNvPr id="42" name="Text Box 8"/>
          <p:cNvSpPr/>
          <p:nvPr/>
        </p:nvSpPr>
        <p:spPr>
          <a:xfrm>
            <a:off x="1314360" y="1295280"/>
            <a:ext cx="1290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c</a:t>
            </a:r>
            <a:r>
              <a:rPr b="0" lang="en-US" sz="14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RIIb </a:t>
            </a:r>
            <a:r>
              <a:rPr b="0" lang="en-US" sz="1400" spc="-1" strike="noStrike" baseline="30000">
                <a:solidFill>
                  <a:srgbClr val="000000"/>
                </a:solidFill>
                <a:latin typeface="Arial"/>
              </a:rPr>
              <a:t>-/-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9"/>
          <p:cNvSpPr/>
          <p:nvPr/>
        </p:nvSpPr>
        <p:spPr>
          <a:xfrm>
            <a:off x="2514600" y="1295280"/>
            <a:ext cx="1382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57/BL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30"/>
          <p:cNvSpPr/>
          <p:nvPr/>
        </p:nvSpPr>
        <p:spPr>
          <a:xfrm rot="16200000">
            <a:off x="3031920" y="2510640"/>
            <a:ext cx="2343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HEMATOCRIT (%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Picture 34" descr=""/>
          <p:cNvPicPr/>
          <p:nvPr/>
        </p:nvPicPr>
        <p:blipFill>
          <a:blip r:embed="rId2"/>
          <a:stretch/>
        </p:blipFill>
        <p:spPr>
          <a:xfrm>
            <a:off x="4419720" y="1325520"/>
            <a:ext cx="4379760" cy="2987640"/>
          </a:xfrm>
          <a:prstGeom prst="rect">
            <a:avLst/>
          </a:prstGeom>
          <a:ln w="0">
            <a:noFill/>
          </a:ln>
        </p:spPr>
      </p:pic>
      <p:grpSp>
        <p:nvGrpSpPr>
          <p:cNvPr id="46" name="Group 37"/>
          <p:cNvGrpSpPr/>
          <p:nvPr/>
        </p:nvGrpSpPr>
        <p:grpSpPr>
          <a:xfrm>
            <a:off x="4971960" y="1343160"/>
            <a:ext cx="2671560" cy="307080"/>
            <a:chOff x="4971960" y="1343160"/>
            <a:chExt cx="2671560" cy="307080"/>
          </a:xfrm>
        </p:grpSpPr>
        <p:sp>
          <p:nvSpPr>
            <p:cNvPr id="47" name="Text Box 38"/>
            <p:cNvSpPr/>
            <p:nvPr/>
          </p:nvSpPr>
          <p:spPr>
            <a:xfrm>
              <a:off x="4971960" y="1343160"/>
              <a:ext cx="128952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Fc</a:t>
              </a:r>
              <a:r>
                <a:rPr b="0" lang="en-US" sz="14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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RIIb </a:t>
              </a:r>
              <a:r>
                <a:rPr b="0" lang="en-US" sz="1400" spc="-1" strike="noStrike" baseline="30000">
                  <a:solidFill>
                    <a:srgbClr val="000000"/>
                  </a:solidFill>
                  <a:latin typeface="Arial"/>
                </a:rPr>
                <a:t>-/-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 Box 39"/>
            <p:cNvSpPr/>
            <p:nvPr/>
          </p:nvSpPr>
          <p:spPr>
            <a:xfrm>
              <a:off x="6261480" y="1343160"/>
              <a:ext cx="138204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C57/BL6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9" name="Text Box 8"/>
          <p:cNvSpPr/>
          <p:nvPr/>
        </p:nvSpPr>
        <p:spPr>
          <a:xfrm>
            <a:off x="857160" y="838080"/>
            <a:ext cx="457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8"/>
          <p:cNvSpPr/>
          <p:nvPr/>
        </p:nvSpPr>
        <p:spPr>
          <a:xfrm>
            <a:off x="4495680" y="954000"/>
            <a:ext cx="457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33"/>
          <p:cNvSpPr/>
          <p:nvPr/>
        </p:nvSpPr>
        <p:spPr>
          <a:xfrm>
            <a:off x="1447920" y="4648320"/>
            <a:ext cx="6095880" cy="59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he Fc</a:t>
            </a:r>
            <a:r>
              <a:rPr b="1" lang="en-US" sz="11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RIIb</a:t>
            </a:r>
            <a:r>
              <a:rPr b="1" lang="en-US" sz="11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-/-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nd “wild type” C57/BL6  have differing baseline platelet and red blood cell counts.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omparison of baseline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(A)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platelet counts and (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B)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hematocrit of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Fc</a:t>
            </a:r>
            <a:r>
              <a:rPr b="0" lang="en-US" sz="11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RII</a:t>
            </a:r>
            <a:r>
              <a:rPr b="0" lang="en-US" sz="1100" spc="-1" strike="noStrike" baseline="30000">
                <a:solidFill>
                  <a:srgbClr val="000000"/>
                </a:solidFill>
                <a:latin typeface="Arial"/>
              </a:rPr>
              <a:t>-/-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and C57/Bl6 mice.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6"/>
          <p:cNvSpPr/>
          <p:nvPr/>
        </p:nvSpPr>
        <p:spPr>
          <a:xfrm rot="16200000">
            <a:off x="-985320" y="2044080"/>
            <a:ext cx="3276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LATELET COUNT (x10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</a:rPr>
              <a:t>3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/</a:t>
            </a:r>
            <a:r>
              <a:rPr b="1" lang="el-GR" sz="1200" spc="-1" strike="noStrike">
                <a:solidFill>
                  <a:srgbClr val="000000"/>
                </a:solidFill>
                <a:latin typeface="Arial"/>
              </a:rPr>
              <a:t>μ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L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19"/>
          <p:cNvSpPr/>
          <p:nvPr/>
        </p:nvSpPr>
        <p:spPr>
          <a:xfrm>
            <a:off x="0" y="-61920"/>
            <a:ext cx="2895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igure S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34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/>
  <dc:description/>
  <dc:language>en-US</dc:language>
  <cp:lastModifiedBy>Ajay Jain</cp:lastModifiedBy>
  <cp:lastPrinted>2012-07-16T16:15:58Z</cp:lastPrinted>
  <dcterms:modified xsi:type="dcterms:W3CDTF">2012-08-16T18:02:25Z</dcterms:modified>
  <cp:revision>434</cp:revision>
  <dc:subject/>
  <dc:title>Slide 1</dc:title>
</cp:coreProperties>
</file>